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96E39-E565-46EA-8BE4-3D6ABA7CE9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DC000-4923-485F-87F5-8443C0DCBE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FB0AE-5CA0-49D5-A399-69A9B1CD7A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284E1-CF60-4C90-A07D-BDEFC22010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00853-1054-4D89-950D-9AAA030EA3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14565-07F1-4360-B3EC-ECAB218590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EB24F-28C7-442E-8682-912E01A4F9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65A16-B4C2-428C-801B-2D1326456C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CFA37-D1A1-4020-9249-EE8F25A346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4E62A-CFEA-4282-9382-60C3247100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EF74A-DCEB-4D12-8FA3-2FDC717343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FA6B7-24E0-4C08-B59E-A3E237648E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5B3F0F-1734-4F8E-BA0E-6102FBB0F65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289800" y="563400"/>
            <a:ext cx="20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ll patients (n=116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1029240" y="1114560"/>
            <a:ext cx="145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3955320" y="1112760"/>
            <a:ext cx="218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8"/>
          <p:cNvSpPr/>
          <p:nvPr/>
        </p:nvSpPr>
        <p:spPr>
          <a:xfrm>
            <a:off x="327240" y="4816440"/>
            <a:ext cx="440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atients who received chemotherapy (n=60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1"/>
          <p:cNvSpPr/>
          <p:nvPr/>
        </p:nvSpPr>
        <p:spPr>
          <a:xfrm>
            <a:off x="948960" y="5592600"/>
            <a:ext cx="145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2"/>
          <p:cNvSpPr/>
          <p:nvPr/>
        </p:nvSpPr>
        <p:spPr>
          <a:xfrm>
            <a:off x="4068720" y="5592600"/>
            <a:ext cx="218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1" descr=""/>
          <p:cNvPicPr/>
          <p:nvPr/>
        </p:nvPicPr>
        <p:blipFill>
          <a:blip r:embed="rId1"/>
          <a:srcRect l="0" t="465" r="3040" b="0"/>
          <a:stretch/>
        </p:blipFill>
        <p:spPr>
          <a:xfrm>
            <a:off x="260280" y="1417680"/>
            <a:ext cx="3321000" cy="27306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3"/>
          <p:cNvSpPr/>
          <p:nvPr/>
        </p:nvSpPr>
        <p:spPr>
          <a:xfrm>
            <a:off x="1760400" y="1739880"/>
            <a:ext cx="84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=0.65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2"/>
          <a:srcRect l="0" t="817" r="2470" b="0"/>
          <a:stretch/>
        </p:blipFill>
        <p:spPr>
          <a:xfrm>
            <a:off x="3489480" y="1428840"/>
            <a:ext cx="3350880" cy="2730240"/>
          </a:xfrm>
          <a:prstGeom prst="rect">
            <a:avLst/>
          </a:prstGeom>
          <a:ln w="0">
            <a:noFill/>
          </a:ln>
        </p:spPr>
      </p:pic>
      <p:sp>
        <p:nvSpPr>
          <p:cNvPr id="50" name="TextBox 14"/>
          <p:cNvSpPr/>
          <p:nvPr/>
        </p:nvSpPr>
        <p:spPr>
          <a:xfrm>
            <a:off x="5190840" y="1738440"/>
            <a:ext cx="84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=0.70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15" descr=""/>
          <p:cNvPicPr/>
          <p:nvPr/>
        </p:nvPicPr>
        <p:blipFill>
          <a:blip r:embed="rId3"/>
          <a:srcRect l="0" t="-112" r="3521" b="0"/>
          <a:stretch/>
        </p:blipFill>
        <p:spPr>
          <a:xfrm>
            <a:off x="3441600" y="5900760"/>
            <a:ext cx="3308400" cy="2751120"/>
          </a:xfrm>
          <a:prstGeom prst="rect">
            <a:avLst/>
          </a:prstGeom>
          <a:ln w="0">
            <a:noFill/>
          </a:ln>
        </p:spPr>
      </p:pic>
      <p:sp>
        <p:nvSpPr>
          <p:cNvPr id="52" name="TextBox 16"/>
          <p:cNvSpPr/>
          <p:nvPr/>
        </p:nvSpPr>
        <p:spPr>
          <a:xfrm>
            <a:off x="5025960" y="6165720"/>
            <a:ext cx="84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=0.94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17" descr=""/>
          <p:cNvPicPr/>
          <p:nvPr/>
        </p:nvPicPr>
        <p:blipFill>
          <a:blip r:embed="rId4"/>
          <a:srcRect l="0" t="412" r="3599" b="0"/>
          <a:stretch/>
        </p:blipFill>
        <p:spPr>
          <a:xfrm>
            <a:off x="82440" y="5911920"/>
            <a:ext cx="3310200" cy="2739960"/>
          </a:xfrm>
          <a:prstGeom prst="rect">
            <a:avLst/>
          </a:prstGeom>
          <a:ln w="0">
            <a:noFill/>
          </a:ln>
        </p:spPr>
      </p:pic>
      <p:sp>
        <p:nvSpPr>
          <p:cNvPr id="54" name="TextBox 18"/>
          <p:cNvSpPr/>
          <p:nvPr/>
        </p:nvSpPr>
        <p:spPr>
          <a:xfrm>
            <a:off x="1634760" y="6164280"/>
            <a:ext cx="84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=0.95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27Z</dcterms:modified>
  <cp:revision>919</cp:revision>
  <dc:subject/>
  <dc:title>PowerPoint Presentation</dc:title>
</cp:coreProperties>
</file>